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1128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886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0611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5439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4591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15401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496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2050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7704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8020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1361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421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FA171-3290-4EA9-A08A-1B6144DFB8BC}" type="datetimeFigureOut">
              <a:rPr lang="en-GB" smtClean="0"/>
              <a:t>2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EF383-EA1C-46E9-9A82-EE4E5191FB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4550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" t="2198" b="-1"/>
          <a:stretch/>
        </p:blipFill>
        <p:spPr bwMode="auto">
          <a:xfrm>
            <a:off x="323528" y="620688"/>
            <a:ext cx="8335021" cy="38753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23528" y="4797152"/>
            <a:ext cx="828092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/>
              <a:t>Figure S1. ssu-rDNA fragment of assemblage C ( accession number GU126443) and assemblage D (accession number GU126444)  aligned with a representative sample (kiJBa006) with “double peaks” (yellow) in the Sanger sequence results.  Positions different in assemblage C and D resulted in “double peaks” , indicating the presence of a mixed infection with assemblage C and D.  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18010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70</Words>
  <Application>Microsoft Office PowerPoint</Application>
  <PresentationFormat>Diavoorstelling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2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esentatie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s</dc:creator>
  <cp:lastModifiedBy>Frans Kooyman</cp:lastModifiedBy>
  <cp:revision>2</cp:revision>
  <dcterms:created xsi:type="dcterms:W3CDTF">2020-10-16T10:31:40Z</dcterms:created>
  <dcterms:modified xsi:type="dcterms:W3CDTF">2020-10-26T12:39:24Z</dcterms:modified>
</cp:coreProperties>
</file>